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3" r:id="rId2"/>
  </p:sldIdLst>
  <p:sldSz cx="6858000" cy="9906000" type="A4"/>
  <p:notesSz cx="9144000" cy="6858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03" autoAdjust="0"/>
    <p:restoredTop sz="94660"/>
  </p:normalViewPr>
  <p:slideViewPr>
    <p:cSldViewPr snapToGrid="0">
      <p:cViewPr varScale="1">
        <p:scale>
          <a:sx n="45" d="100"/>
          <a:sy n="45" d="100"/>
        </p:scale>
        <p:origin x="2073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E2780B-98F6-4E89-8D21-E2BC8715C1FD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E9BDBB-BAB9-462E-BB64-097690E3D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666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8683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686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858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5504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0962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4667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988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04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302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9769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7705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4889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标题 1"/>
          <p:cNvSpPr txBox="1">
            <a:spLocks/>
          </p:cNvSpPr>
          <p:nvPr/>
        </p:nvSpPr>
        <p:spPr>
          <a:xfrm>
            <a:off x="116632" y="128464"/>
            <a:ext cx="3037502" cy="367550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3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90843" y="1161906"/>
            <a:ext cx="6715005" cy="4224948"/>
            <a:chOff x="-908455" y="1129035"/>
            <a:chExt cx="9309648" cy="5857446"/>
          </a:xfrm>
        </p:grpSpPr>
        <p:sp>
          <p:nvSpPr>
            <p:cNvPr id="5" name="TextBox 4"/>
            <p:cNvSpPr txBox="1"/>
            <p:nvPr/>
          </p:nvSpPr>
          <p:spPr>
            <a:xfrm>
              <a:off x="6878496" y="5199401"/>
              <a:ext cx="1522697" cy="704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orafenib</a:t>
              </a:r>
            </a:p>
            <a:p>
              <a:pPr algn="ctr"/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</a:p>
            <a:p>
              <a:pPr algn="ctr"/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SC-J9 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>
              <a:off x="2272953" y="1129035"/>
              <a:ext cx="3143272" cy="36269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 cycle analysis of HA22T</a:t>
              </a:r>
              <a:endParaRPr lang="zh-CN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936937" y="2486357"/>
              <a:ext cx="1405817" cy="704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orafenib</a:t>
              </a:r>
            </a:p>
            <a:p>
              <a:pPr algn="ctr"/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</a:p>
            <a:p>
              <a:pPr algn="ctr"/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-661311" y="2701801"/>
              <a:ext cx="928695" cy="32002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-908455" y="5414844"/>
              <a:ext cx="1388211" cy="32002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SC-J9 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图片 9"/>
            <p:cNvPicPr/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471560" y="1629101"/>
              <a:ext cx="2857520" cy="2571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" name="图片 10"/>
            <p:cNvPicPr/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985052" y="1629101"/>
              <a:ext cx="2857520" cy="2571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2" name="图片 11"/>
            <p:cNvPicPr/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487004" y="4415183"/>
              <a:ext cx="2857520" cy="2571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" name="图片 12"/>
            <p:cNvPicPr/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4000480" y="4415183"/>
              <a:ext cx="2857520" cy="2571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" name="图片 13"/>
            <p:cNvPicPr/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3201648" y="4057993"/>
              <a:ext cx="930671" cy="7716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5" name="Rectangle 2"/>
            <p:cNvSpPr>
              <a:spLocks noChangeArrowheads="1"/>
            </p:cNvSpPr>
            <p:nvPr/>
          </p:nvSpPr>
          <p:spPr bwMode="auto">
            <a:xfrm>
              <a:off x="1808607" y="2075033"/>
              <a:ext cx="1571637" cy="704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G0G1: 64.45 %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900" b="1" dirty="0" smtClean="0">
                  <a:solidFill>
                    <a:srgbClr val="FF0000"/>
                  </a:solidFill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S-Phase: 23.66 %</a:t>
              </a:r>
              <a:r>
                <a:rPr lang="en-US" altLang="zh-CN" sz="900" dirty="0" smtClean="0"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G2M: 11.89 %</a:t>
              </a: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    </a:t>
              </a:r>
            </a:p>
          </p:txBody>
        </p:sp>
        <p:sp>
          <p:nvSpPr>
            <p:cNvPr id="16" name="Rectangle 2"/>
            <p:cNvSpPr>
              <a:spLocks noChangeArrowheads="1"/>
            </p:cNvSpPr>
            <p:nvPr/>
          </p:nvSpPr>
          <p:spPr bwMode="auto">
            <a:xfrm>
              <a:off x="5344789" y="2075033"/>
              <a:ext cx="1571637" cy="704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lvl="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G0G1: 55.60 %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900" b="1" dirty="0" smtClean="0">
                  <a:solidFill>
                    <a:srgbClr val="FF0000"/>
                  </a:solidFill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S-Phase: 37.50 %</a:t>
              </a:r>
              <a:r>
                <a:rPr lang="en-US" altLang="zh-CN" sz="900" dirty="0" smtClean="0"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G2M: 6.90 %</a:t>
              </a: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    </a:t>
              </a:r>
            </a:p>
          </p:txBody>
        </p:sp>
        <p:sp>
          <p:nvSpPr>
            <p:cNvPr id="17" name="Rectangle 2"/>
            <p:cNvSpPr>
              <a:spLocks noChangeArrowheads="1"/>
            </p:cNvSpPr>
            <p:nvPr/>
          </p:nvSpPr>
          <p:spPr bwMode="auto">
            <a:xfrm>
              <a:off x="5344789" y="4789677"/>
              <a:ext cx="1571637" cy="704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G0G1: 48.51 %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900" b="1" dirty="0" smtClean="0">
                  <a:solidFill>
                    <a:srgbClr val="FF0000"/>
                  </a:solidFill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S-Phase: 45.85 %</a:t>
              </a:r>
              <a:r>
                <a:rPr lang="en-US" altLang="zh-CN" sz="900" dirty="0" smtClean="0"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G2M: 5.64 %</a:t>
              </a: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    </a:t>
              </a:r>
            </a:p>
          </p:txBody>
        </p:sp>
        <p:sp>
          <p:nvSpPr>
            <p:cNvPr id="20" name="Rectangle 2"/>
            <p:cNvSpPr>
              <a:spLocks noChangeArrowheads="1"/>
            </p:cNvSpPr>
            <p:nvPr/>
          </p:nvSpPr>
          <p:spPr bwMode="auto">
            <a:xfrm>
              <a:off x="1808607" y="4789677"/>
              <a:ext cx="1571637" cy="704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G0G1: 72.27 %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900" b="1" dirty="0" smtClean="0">
                  <a:solidFill>
                    <a:srgbClr val="FF0000"/>
                  </a:solidFill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S-Phase: 20.04 %</a:t>
              </a:r>
              <a:r>
                <a:rPr lang="en-US" altLang="zh-CN" sz="900" dirty="0" smtClean="0"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G2M: 7.69 %</a:t>
              </a: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宋体" pitchFamily="2" charset="-122"/>
                  <a:cs typeface="Arial" panose="020B0604020202020204" pitchFamily="34" charset="0"/>
                </a:rPr>
                <a:t>     </a:t>
              </a:r>
            </a:p>
          </p:txBody>
        </p:sp>
      </p:grpSp>
      <p:pic>
        <p:nvPicPr>
          <p:cNvPr id="18" name="Picture 2" descr="E:\360云盘\文档\学术\研究生研究\性激素与肝癌\Data\Flow Cytometry\Walter 20141210 Multiple Apoptosis and CC\20141210 SK Apoptosis 48h-Layout.png"/>
          <p:cNvPicPr>
            <a:picLocks noChangeAspect="1" noChangeArrowheads="1"/>
          </p:cNvPicPr>
          <p:nvPr/>
        </p:nvPicPr>
        <p:blipFill rotWithShape="1">
          <a:blip r:embed="rId7"/>
          <a:srcRect t="48706"/>
          <a:stretch/>
        </p:blipFill>
        <p:spPr bwMode="auto">
          <a:xfrm>
            <a:off x="267955" y="6284393"/>
            <a:ext cx="6494180" cy="1800279"/>
          </a:xfrm>
          <a:prstGeom prst="rect">
            <a:avLst/>
          </a:prstGeom>
          <a:noFill/>
        </p:spPr>
      </p:pic>
      <p:sp>
        <p:nvSpPr>
          <p:cNvPr id="21" name="矩形 20"/>
          <p:cNvSpPr/>
          <p:nvPr/>
        </p:nvSpPr>
        <p:spPr>
          <a:xfrm>
            <a:off x="84626" y="760708"/>
            <a:ext cx="318037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/>
          <a:p>
            <a:pPr algn="ctr"/>
            <a:r>
              <a:rPr lang="en-US" altLang="zh-CN" sz="21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84626" y="5961489"/>
            <a:ext cx="318037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/>
          <a:p>
            <a:pPr algn="ctr"/>
            <a:r>
              <a:rPr lang="en-US" altLang="zh-CN" sz="21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892246" y="8094647"/>
            <a:ext cx="67074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6"/>
          <p:cNvSpPr txBox="1"/>
          <p:nvPr/>
        </p:nvSpPr>
        <p:spPr>
          <a:xfrm>
            <a:off x="2337266" y="8094647"/>
            <a:ext cx="10153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orafenib</a:t>
            </a:r>
          </a:p>
        </p:txBody>
      </p:sp>
      <p:sp>
        <p:nvSpPr>
          <p:cNvPr id="25" name="矩形 24"/>
          <p:cNvSpPr/>
          <p:nvPr/>
        </p:nvSpPr>
        <p:spPr>
          <a:xfrm>
            <a:off x="3986671" y="8094647"/>
            <a:ext cx="100262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SC-J9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4"/>
          <p:cNvSpPr txBox="1"/>
          <p:nvPr/>
        </p:nvSpPr>
        <p:spPr>
          <a:xfrm>
            <a:off x="5529247" y="7971536"/>
            <a:ext cx="10997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orafenib</a:t>
            </a:r>
          </a:p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</a:p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SC-J9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6567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95</TotalTime>
  <Words>91</Words>
  <Application>Microsoft Office PowerPoint</Application>
  <PresentationFormat>A4 纸张(210x297 毫米)</PresentationFormat>
  <Paragraphs>3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bined therapy of Sorafenib with ASC-J9®synergisticallysuppresses the HCC progression via alteration of pSTAT3-CCL2/Bcl2 signals</dc:title>
  <dc:creator>Junjie Xu</dc:creator>
  <cp:lastModifiedBy>Junjie Xu</cp:lastModifiedBy>
  <cp:revision>101</cp:revision>
  <dcterms:created xsi:type="dcterms:W3CDTF">2015-05-20T05:34:38Z</dcterms:created>
  <dcterms:modified xsi:type="dcterms:W3CDTF">2016-09-23T03:20:09Z</dcterms:modified>
</cp:coreProperties>
</file>